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2" d="100"/>
          <a:sy n="112" d="100"/>
        </p:scale>
        <p:origin x="-1632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8405" cy="384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C60775-EE7C-4768-8472-FB2E46EA521B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FD4AF7-A761-4100-B291-472CA2405A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37432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4FD4AF7-A761-4100-B291-472CA2405A5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4913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1" name="Group 70"/>
          <p:cNvGrpSpPr/>
          <p:nvPr/>
        </p:nvGrpSpPr>
        <p:grpSpPr>
          <a:xfrm>
            <a:off x="660664" y="301867"/>
            <a:ext cx="7867051" cy="6161128"/>
            <a:chOff x="193830" y="318195"/>
            <a:chExt cx="7867051" cy="6161128"/>
          </a:xfrm>
        </p:grpSpPr>
        <p:sp>
          <p:nvSpPr>
            <p:cNvPr id="4" name="TextBox 3"/>
            <p:cNvSpPr txBox="1"/>
            <p:nvPr/>
          </p:nvSpPr>
          <p:spPr>
            <a:xfrm>
              <a:off x="2884321" y="318195"/>
              <a:ext cx="1342034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lf or non-self?</a:t>
              </a:r>
            </a:p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secticidal dsRNA</a:t>
              </a:r>
            </a:p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w dose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600424" y="1333053"/>
              <a:ext cx="1965602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ndocytosis</a:t>
              </a:r>
            </a:p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fficient escape to cytoplasm</a:t>
              </a:r>
            </a:p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permissive insects)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344923" y="2514600"/>
              <a:ext cx="61747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cer-2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333702" y="3258979"/>
              <a:ext cx="6399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RNAs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398486" y="4038600"/>
              <a:ext cx="5485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go-2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123712" y="4800600"/>
              <a:ext cx="11288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arget silencing</a:t>
              </a:r>
            </a:p>
            <a:p>
              <a:pPr algn="ctr"/>
              <a:r>
                <a:rPr lang="en-US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henotype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60586" y="2523608"/>
              <a:ext cx="78739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GAS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like</a:t>
              </a:r>
            </a:p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ceptor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endParaRPr lang="en-US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64666" y="3276600"/>
              <a:ext cx="100860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yclic</a:t>
              </a:r>
            </a:p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nucleotide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endParaRPr lang="en-US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91001" y="4038600"/>
              <a:ext cx="5757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ING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28600" y="4800600"/>
              <a:ext cx="116570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F-</a:t>
              </a:r>
              <a:r>
                <a:rPr lang="el-G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κ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nate immunity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223415" y="318195"/>
              <a:ext cx="1342034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lf or non-self?</a:t>
              </a:r>
            </a:p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secticidal dsRNA</a:t>
              </a:r>
            </a:p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gh dose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943450" y="1371600"/>
              <a:ext cx="1903085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ndocytosis</a:t>
              </a:r>
            </a:p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ccumulation in endosomes</a:t>
              </a:r>
            </a:p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recalcitrant insects)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349891" y="2496979"/>
              <a:ext cx="11624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ress response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358706" y="3200400"/>
              <a:ext cx="114486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cer-2 &amp; Ago-2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840401" y="3944779"/>
              <a:ext cx="2220480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nate immunity</a:t>
              </a:r>
            </a:p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gulation stress response genes</a:t>
              </a:r>
            </a:p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teration in translation</a:t>
              </a: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5835990" y="2438400"/>
              <a:ext cx="2209800" cy="210434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2958990" y="2438400"/>
              <a:ext cx="1384410" cy="281940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2" name="Straight Connector 21"/>
            <p:cNvCxnSpPr/>
            <p:nvPr/>
          </p:nvCxnSpPr>
          <p:spPr>
            <a:xfrm flipH="1">
              <a:off x="4473214" y="3352800"/>
              <a:ext cx="1305250" cy="0"/>
            </a:xfrm>
            <a:prstGeom prst="line">
              <a:avLst/>
            </a:prstGeom>
            <a:ln w="317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 flipH="1">
              <a:off x="4226355" y="3352800"/>
              <a:ext cx="457200" cy="0"/>
            </a:xfrm>
            <a:prstGeom prst="line">
              <a:avLst/>
            </a:prstGeom>
            <a:ln w="31750"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/>
            <p:cNvSpPr txBox="1"/>
            <p:nvPr/>
          </p:nvSpPr>
          <p:spPr>
            <a:xfrm>
              <a:off x="6876300" y="1992224"/>
              <a:ext cx="10294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ll9 receptor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654132" y="2877979"/>
              <a:ext cx="6046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sRBP</a:t>
              </a:r>
              <a:endParaRPr lang="en-US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682711" y="3675758"/>
              <a:ext cx="6046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sRBP</a:t>
              </a:r>
              <a:endParaRPr lang="en-US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384992" y="5925325"/>
              <a:ext cx="1572867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irus dsRNA (non-self)</a:t>
              </a:r>
            </a:p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w/high dose</a:t>
              </a:r>
            </a:p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ytoplasm</a:t>
              </a:r>
            </a:p>
          </p:txBody>
        </p:sp>
        <p:sp>
          <p:nvSpPr>
            <p:cNvPr id="30" name="Rectangle 29"/>
            <p:cNvSpPr/>
            <p:nvPr/>
          </p:nvSpPr>
          <p:spPr>
            <a:xfrm>
              <a:off x="193830" y="2438400"/>
              <a:ext cx="1177160" cy="281940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119429" y="5217439"/>
              <a:ext cx="1640186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irus infection</a:t>
              </a:r>
            </a:p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ytoplasm/nucleus</a:t>
              </a:r>
            </a:p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MP</a:t>
              </a:r>
            </a:p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MP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897123" y="2514600"/>
              <a:ext cx="61747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cer-2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600200" y="3237243"/>
              <a:ext cx="116570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F-</a:t>
              </a:r>
              <a:r>
                <a:rPr lang="el-G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κ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nate immunity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600200" y="4082153"/>
              <a:ext cx="116570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Jak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STAT</a:t>
              </a:r>
            </a:p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nate immunity</a:t>
              </a: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1524000" y="2438400"/>
              <a:ext cx="1281370" cy="281940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895600" y="4038600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SR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895600" y="3276600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SR</a:t>
              </a:r>
            </a:p>
          </p:txBody>
        </p:sp>
        <p:cxnSp>
          <p:nvCxnSpPr>
            <p:cNvPr id="42" name="Straight Arrow Connector 41"/>
            <p:cNvCxnSpPr/>
            <p:nvPr/>
          </p:nvCxnSpPr>
          <p:spPr>
            <a:xfrm>
              <a:off x="3573470" y="855865"/>
              <a:ext cx="0" cy="53340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/>
            <p:cNvCxnSpPr/>
            <p:nvPr/>
          </p:nvCxnSpPr>
          <p:spPr>
            <a:xfrm>
              <a:off x="3573470" y="1854395"/>
              <a:ext cx="0" cy="53340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Arrow Connector 44"/>
            <p:cNvCxnSpPr/>
            <p:nvPr/>
          </p:nvCxnSpPr>
          <p:spPr>
            <a:xfrm>
              <a:off x="3611875" y="2737710"/>
              <a:ext cx="0" cy="53340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Arrow Connector 45"/>
            <p:cNvCxnSpPr/>
            <p:nvPr/>
          </p:nvCxnSpPr>
          <p:spPr>
            <a:xfrm>
              <a:off x="3611875" y="3505810"/>
              <a:ext cx="0" cy="53340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/>
            <p:cNvCxnSpPr/>
            <p:nvPr/>
          </p:nvCxnSpPr>
          <p:spPr>
            <a:xfrm>
              <a:off x="3611875" y="4316585"/>
              <a:ext cx="0" cy="53340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Arrow Connector 47"/>
            <p:cNvCxnSpPr/>
            <p:nvPr/>
          </p:nvCxnSpPr>
          <p:spPr>
            <a:xfrm>
              <a:off x="6908731" y="3429000"/>
              <a:ext cx="0" cy="53340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Arrow Connector 48"/>
            <p:cNvCxnSpPr/>
            <p:nvPr/>
          </p:nvCxnSpPr>
          <p:spPr>
            <a:xfrm>
              <a:off x="6908731" y="2699305"/>
              <a:ext cx="0" cy="53340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/>
            <p:cNvCxnSpPr/>
            <p:nvPr/>
          </p:nvCxnSpPr>
          <p:spPr>
            <a:xfrm>
              <a:off x="2190890" y="2758308"/>
              <a:ext cx="0" cy="53340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Arrow Connector 53"/>
            <p:cNvCxnSpPr/>
            <p:nvPr/>
          </p:nvCxnSpPr>
          <p:spPr>
            <a:xfrm>
              <a:off x="2190890" y="3603218"/>
              <a:ext cx="0" cy="53340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Arrow Connector 54"/>
            <p:cNvCxnSpPr/>
            <p:nvPr/>
          </p:nvCxnSpPr>
          <p:spPr>
            <a:xfrm>
              <a:off x="763931" y="2946063"/>
              <a:ext cx="0" cy="374021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Arrow Connector 56"/>
            <p:cNvCxnSpPr/>
            <p:nvPr/>
          </p:nvCxnSpPr>
          <p:spPr>
            <a:xfrm>
              <a:off x="769905" y="4278180"/>
              <a:ext cx="0" cy="53340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 flipH="1">
              <a:off x="808310" y="2008015"/>
              <a:ext cx="2764641" cy="0"/>
            </a:xfrm>
            <a:prstGeom prst="line">
              <a:avLst/>
            </a:prstGeom>
            <a:ln w="317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Arrow Connector 59"/>
            <p:cNvCxnSpPr/>
            <p:nvPr/>
          </p:nvCxnSpPr>
          <p:spPr>
            <a:xfrm>
              <a:off x="6914705" y="855865"/>
              <a:ext cx="0" cy="53340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Arrow Connector 60"/>
            <p:cNvCxnSpPr/>
            <p:nvPr/>
          </p:nvCxnSpPr>
          <p:spPr>
            <a:xfrm>
              <a:off x="6914705" y="1892800"/>
              <a:ext cx="0" cy="53340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Arrow Connector 62"/>
            <p:cNvCxnSpPr/>
            <p:nvPr/>
          </p:nvCxnSpPr>
          <p:spPr>
            <a:xfrm>
              <a:off x="2152485" y="2008015"/>
              <a:ext cx="0" cy="38405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Arrow Connector 64"/>
            <p:cNvCxnSpPr/>
            <p:nvPr/>
          </p:nvCxnSpPr>
          <p:spPr>
            <a:xfrm>
              <a:off x="808310" y="2008015"/>
              <a:ext cx="0" cy="38405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Arrow Connector 23"/>
            <p:cNvCxnSpPr/>
            <p:nvPr/>
          </p:nvCxnSpPr>
          <p:spPr>
            <a:xfrm flipV="1">
              <a:off x="2152485" y="5387655"/>
              <a:ext cx="0" cy="53767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>
              <a:off x="693095" y="5656490"/>
              <a:ext cx="2957185" cy="0"/>
            </a:xfrm>
            <a:prstGeom prst="line">
              <a:avLst/>
            </a:prstGeom>
            <a:ln w="317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/>
            <p:cNvCxnSpPr/>
            <p:nvPr/>
          </p:nvCxnSpPr>
          <p:spPr>
            <a:xfrm flipV="1">
              <a:off x="3650280" y="5387655"/>
              <a:ext cx="0" cy="268835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Arrow Connector 61"/>
            <p:cNvCxnSpPr/>
            <p:nvPr/>
          </p:nvCxnSpPr>
          <p:spPr>
            <a:xfrm flipV="1">
              <a:off x="693095" y="5387655"/>
              <a:ext cx="0" cy="268835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Arrow Connector 63"/>
            <p:cNvCxnSpPr/>
            <p:nvPr/>
          </p:nvCxnSpPr>
          <p:spPr>
            <a:xfrm flipV="1">
              <a:off x="6953110" y="4657960"/>
              <a:ext cx="0" cy="53767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>
              <a:off x="3305855" y="4158695"/>
              <a:ext cx="115215" cy="0"/>
            </a:xfrm>
            <a:prstGeom prst="line">
              <a:avLst/>
            </a:prstGeom>
            <a:ln w="317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/>
            <p:cNvCxnSpPr/>
            <p:nvPr/>
          </p:nvCxnSpPr>
          <p:spPr>
            <a:xfrm>
              <a:off x="3304635" y="4158695"/>
              <a:ext cx="268835" cy="0"/>
            </a:xfrm>
            <a:prstGeom prst="line">
              <a:avLst/>
            </a:prstGeom>
            <a:ln w="31750"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>
              <a:off x="3267450" y="3390595"/>
              <a:ext cx="115215" cy="0"/>
            </a:xfrm>
            <a:prstGeom prst="line">
              <a:avLst/>
            </a:prstGeom>
            <a:ln w="317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/>
            <p:cNvCxnSpPr/>
            <p:nvPr/>
          </p:nvCxnSpPr>
          <p:spPr>
            <a:xfrm>
              <a:off x="3266230" y="3390595"/>
              <a:ext cx="268835" cy="0"/>
            </a:xfrm>
            <a:prstGeom prst="line">
              <a:avLst/>
            </a:prstGeom>
            <a:ln w="31750"/>
            <a:scene3d>
              <a:camera prst="orthographicFront">
                <a:rot lat="0" lon="0" rev="5400000"/>
              </a:camera>
              <a:lightRig rig="threePt" dir="t"/>
            </a:scene3d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68" name="Straight Arrow Connector 67"/>
          <p:cNvCxnSpPr/>
          <p:nvPr/>
        </p:nvCxnSpPr>
        <p:spPr>
          <a:xfrm>
            <a:off x="1230765" y="3669459"/>
            <a:ext cx="0" cy="374021"/>
          </a:xfrm>
          <a:prstGeom prst="straightConnector1">
            <a:avLst/>
          </a:prstGeom>
          <a:ln w="317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54356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</TotalTime>
  <Words>92</Words>
  <Application>Microsoft Office PowerPoint</Application>
  <PresentationFormat>On-screen Show (4:3)</PresentationFormat>
  <Paragraphs>4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</dc:creator>
  <cp:lastModifiedBy>Luc</cp:lastModifiedBy>
  <cp:revision>8</cp:revision>
  <dcterms:created xsi:type="dcterms:W3CDTF">2006-08-16T00:00:00Z</dcterms:created>
  <dcterms:modified xsi:type="dcterms:W3CDTF">2025-11-17T12:33:11Z</dcterms:modified>
</cp:coreProperties>
</file>